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7" d="100"/>
          <a:sy n="47" d="100"/>
        </p:scale>
        <p:origin x="219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731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132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915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8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158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801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27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35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642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866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68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9D30E-21B5-4C0F-9F44-DC7C4D1C6A14}" type="datetimeFigureOut">
              <a:rPr lang="en-US" smtClean="0"/>
              <a:t>2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3676E-8902-476E-8972-AA304C7E742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62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7A0B3D0-B8ED-5A8C-0A61-465E0EF16256}"/>
              </a:ext>
            </a:extLst>
          </p:cNvPr>
          <p:cNvGrpSpPr/>
          <p:nvPr/>
        </p:nvGrpSpPr>
        <p:grpSpPr>
          <a:xfrm>
            <a:off x="1289234" y="169213"/>
            <a:ext cx="4267200" cy="7680960"/>
            <a:chOff x="1289234" y="169213"/>
            <a:chExt cx="4267200" cy="768096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4621621-C9DF-69CD-0947-68E38E7D48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89235" y="169213"/>
              <a:ext cx="4267199" cy="256032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2815CBA-C2DE-1AE2-22A1-BCD07F534B8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89234" y="2729533"/>
              <a:ext cx="4261510" cy="256032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7B45A19-B084-C5C7-FA2B-4B8F9B859A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89234" y="5289853"/>
              <a:ext cx="4261510" cy="2560320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04DD02F-CB47-3368-6E0E-653BB667C52B}"/>
              </a:ext>
            </a:extLst>
          </p:cNvPr>
          <p:cNvSpPr txBox="1"/>
          <p:nvPr/>
        </p:nvSpPr>
        <p:spPr>
          <a:xfrm>
            <a:off x="324900" y="8045872"/>
            <a:ext cx="62859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5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xpression level in ‘Granny Smith’ (white bar) and ‘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adina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’ (grey bar) apple cultivar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henylalanine ammonia-lyase 1 (PAL)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es. The error bars correspond to the standard deviation. RA= Regular Atmosphere; 1-MCP= Regular Atmosphere + 1-MCP treatment; LO= Low Oxygen condition. FPKM= fragments per kilobase of transcript per million fragments mapped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47B7AA-303B-6B86-F7DF-C4A44D4C4E39}"/>
              </a:ext>
            </a:extLst>
          </p:cNvPr>
          <p:cNvSpPr txBox="1"/>
          <p:nvPr/>
        </p:nvSpPr>
        <p:spPr>
          <a:xfrm>
            <a:off x="228599" y="97038"/>
            <a:ext cx="1813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89"/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. Fig. 5</a:t>
            </a:r>
          </a:p>
        </p:txBody>
      </p:sp>
    </p:spTree>
    <p:extLst>
      <p:ext uri="{BB962C8B-B14F-4D97-AF65-F5344CB8AC3E}">
        <p14:creationId xmlns:p14="http://schemas.microsoft.com/office/powerpoint/2010/main" val="2790165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79</Words>
  <Application>Microsoft Office PowerPoint</Application>
  <PresentationFormat>Presentazione su schermo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</vt:vector>
  </TitlesOfParts>
  <Company>Fondazione Edmund Ma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pulin</dc:creator>
  <cp:lastModifiedBy>lorenzo vittani</cp:lastModifiedBy>
  <cp:revision>11</cp:revision>
  <dcterms:created xsi:type="dcterms:W3CDTF">2022-06-20T07:44:05Z</dcterms:created>
  <dcterms:modified xsi:type="dcterms:W3CDTF">2023-02-20T17:24:43Z</dcterms:modified>
</cp:coreProperties>
</file>